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3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687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DED56D-9CCA-1371-0EF6-A2555F796F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4E0D85F-36E8-D8DB-FCE4-8047A2C132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770E5F-56C9-E0E4-79EF-80C2CC08C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463849-F1C8-29E3-3FA8-F5A61795F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E7E1B8-9E83-FD27-FD73-C25AE5616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362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6F41666-B0A0-F534-181C-F0EA767070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3AB4E9A-53D5-7A77-A021-9C8E8C7CC1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42AAE0C-EA5A-946B-A349-10BC9956E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54D65F-E213-BBDB-63B5-F2C7DD218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44A5193-A148-AF66-D543-0B9DC682D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4486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25A2BD1-1A42-4E75-3BBC-BF7C76294B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9CEC686-5B08-D2AE-A685-EB7BFDD6A7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F21086-D0F3-C6D4-9B5C-0C52382D6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73F6E9-0343-C9F7-4BDC-FF1B9D6BD3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95AC0F-3F53-07C9-3005-AC5EEA4D0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7799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63D78D-F8F8-C4E5-5A67-FA20BCC3E7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14E7A07-CD52-AE00-7476-EF9F4218BA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F0D709-8A94-BE0E-58C3-D6D398E1A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209C96-95CD-0AA7-AF35-D6FCCF49B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C838E2-E97B-0A80-D290-ABC5FD44C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187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F8E6E1-684A-1664-B76D-692467AFFC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29DEDED-848A-2B78-B4A0-55509590D8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F234C0-AD37-AE65-A9F8-706EA32E4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E5AC72-33B3-E7C1-C160-1CABB6D17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16051A-A047-499B-71FA-314A8CD91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1643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133F28-D4FA-8B62-3765-B277AA084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84903FA-F3E1-549A-33C2-E2A4DB9AD9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A9D9A35-A720-F2A0-3A07-72059046DD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C5275EF-7899-0116-5D8D-DC72D66DB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A16E2D-B80C-5C83-A20C-FD21395E2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90FF48C-622B-FFD2-C117-7C0F608A5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0953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3AE55C-AA67-CE8C-B340-78F5ED216C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2DCBFF2-7786-4E4B-F111-4FDB9E65BC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F12BD92-2015-CC98-1992-52FB6CDA13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2C4460-E3FD-F32C-E690-276F9EE7E9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EF2484C-9525-C97A-3FB4-2F3E6964DA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16020E3-5354-C4E0-F55D-F063A7B15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F014BA1-A8CF-3F6C-AF02-1E0ADC111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0C7BA2A-D2AE-4E5A-EA9E-EF9619075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0778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10682D-19ED-F5E6-FA72-26EBE0B1A8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BD4B24D-00AF-F402-642C-93CB08D27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FF1C1D1-5460-464B-8B68-F3EAFD96F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D10FC97-D046-86F2-8174-EF4141E0F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5014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9BA31EB-5A35-F3C8-5BB7-599751460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FF2AFAE-22BA-0DBB-73AD-29ABDED9AF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5F61440-7459-1766-0645-E1473052A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785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E008D5-C099-ABA2-D2C1-8DFD151A7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3AF9500-B550-F743-2397-91ECAFE4E6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3344A04-0018-8D22-57BF-1A7BF578D4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058CD90-9611-0BB2-B351-993840763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17F6397-A991-8932-0FAF-6310F7228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FB6E764-624C-8A6E-2F92-202B4E9DD0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6742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3B1536-4E4C-65F1-8A4A-0B298A833C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D80B655-59D9-2C3A-9F49-0FDA4FB50B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45D7355-3063-D7B4-05BB-FF9A333752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DB56076-F6C1-7B4E-E935-58FA7B120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C085071-01B9-CBAF-74B8-1FF03EC44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232A87B-9A4F-2A56-BD57-8D991FF66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9899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7D42C2E-586F-905B-EDA1-DE9FF01E6B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FAB0EEC-0879-FBD4-F39F-A6FE74C8F7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1BCB60-6701-1638-60C6-DD2C77F0ED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4E1FDD-21E9-4A9A-B38D-B11853A25D27}" type="datetimeFigureOut">
              <a:rPr lang="zh-CN" altLang="en-US" smtClean="0"/>
              <a:t>2024/4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DAAE92-792F-795E-94D2-D44392A0D8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1022BB-12A9-4256-7946-E30C18CA24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846913-C86D-49A6-9972-9DA595DDF8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3732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52A067C-AA2F-FB35-2920-40D5FB9640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8909" y="1277519"/>
            <a:ext cx="2590819" cy="1981214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3C9EAFCC-C2B0-1595-F925-EF72E46ECEC7}"/>
              </a:ext>
            </a:extLst>
          </p:cNvPr>
          <p:cNvSpPr/>
          <p:nvPr/>
        </p:nvSpPr>
        <p:spPr>
          <a:xfrm>
            <a:off x="784168" y="397628"/>
            <a:ext cx="1031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995C8357-5BD2-0A5E-46FB-1B2CCFBC1F2A}"/>
              </a:ext>
            </a:extLst>
          </p:cNvPr>
          <p:cNvSpPr/>
          <p:nvPr/>
        </p:nvSpPr>
        <p:spPr>
          <a:xfrm>
            <a:off x="784168" y="4351923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B846A327-A92B-49D7-02A5-FD61E6F79F4F}"/>
              </a:ext>
            </a:extLst>
          </p:cNvPr>
          <p:cNvSpPr/>
          <p:nvPr/>
        </p:nvSpPr>
        <p:spPr>
          <a:xfrm>
            <a:off x="940756" y="1517133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HOXD9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E4740CAA-F8C6-B426-5366-3AD926B206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88909" y="3567413"/>
            <a:ext cx="2438418" cy="1938352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515D0A02-C8AB-569C-84DE-659D6AEF49F1}"/>
              </a:ext>
            </a:extLst>
          </p:cNvPr>
          <p:cNvSpPr/>
          <p:nvPr/>
        </p:nvSpPr>
        <p:spPr>
          <a:xfrm>
            <a:off x="5463358" y="2010068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FDCDB88E-129A-4FDB-F396-77D03C1DCC45}"/>
              </a:ext>
            </a:extLst>
          </p:cNvPr>
          <p:cNvSpPr/>
          <p:nvPr/>
        </p:nvSpPr>
        <p:spPr>
          <a:xfrm>
            <a:off x="5379728" y="4293935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6366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2123C3E-3396-6E9D-1390-4DBD2C4672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479" y="1155589"/>
            <a:ext cx="2838471" cy="2062178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1D6976D4-CC41-C669-0ECE-A0252578ABCF}"/>
              </a:ext>
            </a:extLst>
          </p:cNvPr>
          <p:cNvSpPr/>
          <p:nvPr/>
        </p:nvSpPr>
        <p:spPr>
          <a:xfrm>
            <a:off x="784168" y="397628"/>
            <a:ext cx="1031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AE16C55A-E065-3F15-AB34-75773CC2BD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3993" y="3508141"/>
            <a:ext cx="2257442" cy="1743088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A06EF6C2-79C1-5FE7-7B4B-45B44E692BA9}"/>
              </a:ext>
            </a:extLst>
          </p:cNvPr>
          <p:cNvSpPr/>
          <p:nvPr/>
        </p:nvSpPr>
        <p:spPr>
          <a:xfrm>
            <a:off x="4481950" y="4142586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297478A6-A33F-A594-FBD2-16EBFB81073D}"/>
              </a:ext>
            </a:extLst>
          </p:cNvPr>
          <p:cNvSpPr/>
          <p:nvPr/>
        </p:nvSpPr>
        <p:spPr>
          <a:xfrm>
            <a:off x="4481950" y="2530748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75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37522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06FF78D-8DFA-52CC-71CA-D191CE7EB2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15286" y="928559"/>
            <a:ext cx="2712257" cy="2841583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A8AE424F-3D8C-6AB6-7B06-A1AF3FC076EA}"/>
              </a:ext>
            </a:extLst>
          </p:cNvPr>
          <p:cNvSpPr/>
          <p:nvPr/>
        </p:nvSpPr>
        <p:spPr>
          <a:xfrm>
            <a:off x="784168" y="397628"/>
            <a:ext cx="1031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A1DC66AB-5CAC-E2F8-54D4-E11328680DC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2403"/>
          <a:stretch/>
        </p:blipFill>
        <p:spPr>
          <a:xfrm>
            <a:off x="464457" y="1259811"/>
            <a:ext cx="2877833" cy="112393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2FF8C450-BA79-57E4-2292-6BAFC6182C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90154" y="1591539"/>
            <a:ext cx="2768435" cy="104185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272871A-B650-5939-17B0-49A2D55AECD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21952" y="2839511"/>
            <a:ext cx="3118337" cy="1105961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5362016F-B285-41F6-D47B-9A206D33E070}"/>
              </a:ext>
            </a:extLst>
          </p:cNvPr>
          <p:cNvSpPr/>
          <p:nvPr/>
        </p:nvSpPr>
        <p:spPr>
          <a:xfrm>
            <a:off x="7933741" y="1927799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4EA2BD7A-D7C7-15B1-F353-73325DCD76C7}"/>
              </a:ext>
            </a:extLst>
          </p:cNvPr>
          <p:cNvSpPr/>
          <p:nvPr/>
        </p:nvSpPr>
        <p:spPr>
          <a:xfrm>
            <a:off x="7990497" y="3207825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54B938CC-DF70-F5E4-2162-4DF15EBE4576}"/>
              </a:ext>
            </a:extLst>
          </p:cNvPr>
          <p:cNvSpPr/>
          <p:nvPr/>
        </p:nvSpPr>
        <p:spPr>
          <a:xfrm>
            <a:off x="3451444" y="1476695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09F1F7AB-13EF-08E8-9570-0387EA9DAE32}"/>
              </a:ext>
            </a:extLst>
          </p:cNvPr>
          <p:cNvSpPr/>
          <p:nvPr/>
        </p:nvSpPr>
        <p:spPr>
          <a:xfrm>
            <a:off x="3467036" y="1743133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49B22902-340A-1637-6FA2-906E6AD20A9A}"/>
              </a:ext>
            </a:extLst>
          </p:cNvPr>
          <p:cNvSpPr/>
          <p:nvPr/>
        </p:nvSpPr>
        <p:spPr>
          <a:xfrm>
            <a:off x="3467036" y="4232508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B780E198-9BEF-7B99-7B3E-EF9E98511773}"/>
              </a:ext>
            </a:extLst>
          </p:cNvPr>
          <p:cNvSpPr/>
          <p:nvPr/>
        </p:nvSpPr>
        <p:spPr>
          <a:xfrm>
            <a:off x="3482628" y="4498946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EF2B6F90-2A44-E7BE-0E14-F36E3A55C80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3516"/>
          <a:stretch/>
        </p:blipFill>
        <p:spPr>
          <a:xfrm>
            <a:off x="464456" y="4181015"/>
            <a:ext cx="2877833" cy="8615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6025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949BCE91-6124-CE0E-20C0-D7FDC48DB3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331196" y="1495166"/>
            <a:ext cx="2825661" cy="168853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634389B-04AE-A6E4-B9DD-0973D47BDA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8952" y="4299325"/>
            <a:ext cx="1784592" cy="1352792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CB2F6281-F2CA-5F04-F70B-B8AA55C9A617}"/>
              </a:ext>
            </a:extLst>
          </p:cNvPr>
          <p:cNvSpPr/>
          <p:nvPr/>
        </p:nvSpPr>
        <p:spPr>
          <a:xfrm>
            <a:off x="449877" y="752689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2CC9D882-BB17-D799-8707-C9A820FBBF99}"/>
              </a:ext>
            </a:extLst>
          </p:cNvPr>
          <p:cNvSpPr/>
          <p:nvPr/>
        </p:nvSpPr>
        <p:spPr>
          <a:xfrm>
            <a:off x="-181319" y="4791055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B413DF1E-0044-6CBC-83CF-5D25F3A9DD6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62285" y="4554751"/>
            <a:ext cx="2082799" cy="1254413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E881155-C223-4AAB-71EE-C26227DC77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24106" y="1495166"/>
            <a:ext cx="2652259" cy="1341813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F88BBEF8-A89F-9690-41D0-FDDA47A9FB74}"/>
              </a:ext>
            </a:extLst>
          </p:cNvPr>
          <p:cNvSpPr/>
          <p:nvPr/>
        </p:nvSpPr>
        <p:spPr>
          <a:xfrm>
            <a:off x="7816339" y="2075933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PINK1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0DA78BDD-7786-0FF4-CDFA-8B75ADAD69E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98861" y="4142277"/>
            <a:ext cx="2238391" cy="166688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75E733F-BAC9-1834-D698-0FDC8D45DA4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34650" y="461594"/>
            <a:ext cx="2414605" cy="1924064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86896E8F-14BB-5DE0-07E3-8E717B740C7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63252" y="2553416"/>
            <a:ext cx="2186003" cy="1833576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CFCA0DA6-40FF-0724-26BE-A8FEA7B8574B}"/>
              </a:ext>
            </a:extLst>
          </p:cNvPr>
          <p:cNvSpPr/>
          <p:nvPr/>
        </p:nvSpPr>
        <p:spPr>
          <a:xfrm>
            <a:off x="2686652" y="4812625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1C1311F4-5F36-66E1-B1E1-A174B043CC59}"/>
              </a:ext>
            </a:extLst>
          </p:cNvPr>
          <p:cNvSpPr/>
          <p:nvPr/>
        </p:nvSpPr>
        <p:spPr>
          <a:xfrm>
            <a:off x="6900704" y="4907218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B6CD0D7D-7008-6BD8-6095-E1BA587735D9}"/>
              </a:ext>
            </a:extLst>
          </p:cNvPr>
          <p:cNvSpPr/>
          <p:nvPr/>
        </p:nvSpPr>
        <p:spPr>
          <a:xfrm>
            <a:off x="11337252" y="4836105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EEC13111-2662-AEF3-F130-293A8B70D2A4}"/>
              </a:ext>
            </a:extLst>
          </p:cNvPr>
          <p:cNvSpPr/>
          <p:nvPr/>
        </p:nvSpPr>
        <p:spPr>
          <a:xfrm>
            <a:off x="11260773" y="1809495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0C133ADA-D503-FBD0-6D91-34A1CC4070FA}"/>
              </a:ext>
            </a:extLst>
          </p:cNvPr>
          <p:cNvSpPr/>
          <p:nvPr/>
        </p:nvSpPr>
        <p:spPr>
          <a:xfrm>
            <a:off x="11276365" y="2075933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F77835CD-CD2A-A639-EB6D-B56D81E0EA7C}"/>
              </a:ext>
            </a:extLst>
          </p:cNvPr>
          <p:cNvSpPr/>
          <p:nvPr/>
        </p:nvSpPr>
        <p:spPr>
          <a:xfrm>
            <a:off x="3156857" y="2075933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B4466DF9-DB4B-ADC3-1DAA-2A349026A47E}"/>
              </a:ext>
            </a:extLst>
          </p:cNvPr>
          <p:cNvSpPr/>
          <p:nvPr/>
        </p:nvSpPr>
        <p:spPr>
          <a:xfrm>
            <a:off x="3172449" y="2342371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75F8C95E-61AF-5592-50C1-58FA8316CB62}"/>
              </a:ext>
            </a:extLst>
          </p:cNvPr>
          <p:cNvSpPr/>
          <p:nvPr/>
        </p:nvSpPr>
        <p:spPr>
          <a:xfrm>
            <a:off x="6808428" y="1581450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7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BE8DF277-8E46-80A0-52B4-2620B671104D}"/>
              </a:ext>
            </a:extLst>
          </p:cNvPr>
          <p:cNvSpPr/>
          <p:nvPr/>
        </p:nvSpPr>
        <p:spPr>
          <a:xfrm>
            <a:off x="6900704" y="3652805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6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67678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673E179-D324-1276-804B-827797B20A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8108" y="849306"/>
            <a:ext cx="2395555" cy="1704987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AA410259-7116-ECEE-1A64-8B5CE002EFCA}"/>
              </a:ext>
            </a:extLst>
          </p:cNvPr>
          <p:cNvSpPr/>
          <p:nvPr/>
        </p:nvSpPr>
        <p:spPr>
          <a:xfrm>
            <a:off x="784168" y="397628"/>
            <a:ext cx="1031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A1DFB3C5-894D-5EA6-4D95-924F50EF9C02}"/>
              </a:ext>
            </a:extLst>
          </p:cNvPr>
          <p:cNvSpPr/>
          <p:nvPr/>
        </p:nvSpPr>
        <p:spPr>
          <a:xfrm>
            <a:off x="7061596" y="1332467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PINK1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D85474A-A306-BA74-B29A-EF50AD02B4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43268" y="3745010"/>
            <a:ext cx="1968230" cy="1748198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12832E4D-BCBB-5356-D313-277CB3D5EDF7}"/>
              </a:ext>
            </a:extLst>
          </p:cNvPr>
          <p:cNvSpPr/>
          <p:nvPr/>
        </p:nvSpPr>
        <p:spPr>
          <a:xfrm>
            <a:off x="784168" y="4351923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8F44CE92-0A9B-8566-88AC-1A44057BE64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33010" y="1097240"/>
            <a:ext cx="2757508" cy="1838338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D9B402B6-7B33-C3DF-61E0-74DB74809863}"/>
              </a:ext>
            </a:extLst>
          </p:cNvPr>
          <p:cNvSpPr/>
          <p:nvPr/>
        </p:nvSpPr>
        <p:spPr>
          <a:xfrm>
            <a:off x="940756" y="1517133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HOXD9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0BFEC3E2-6CCB-3240-7F20-EB5DB9C842CF}"/>
              </a:ext>
            </a:extLst>
          </p:cNvPr>
          <p:cNvSpPr/>
          <p:nvPr/>
        </p:nvSpPr>
        <p:spPr>
          <a:xfrm>
            <a:off x="7210193" y="3745009"/>
            <a:ext cx="8771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7ABA3F3C-2757-83D3-FC84-8A8A275817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96732" y="3554198"/>
            <a:ext cx="2395555" cy="1767645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F0C9CC46-B4BD-44D5-16D1-5A3E1158AC1E}"/>
              </a:ext>
            </a:extLst>
          </p:cNvPr>
          <p:cNvSpPr/>
          <p:nvPr/>
        </p:nvSpPr>
        <p:spPr>
          <a:xfrm>
            <a:off x="4786945" y="4893024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51D39293-E556-66DF-6928-E50AB86E0FD9}"/>
              </a:ext>
            </a:extLst>
          </p:cNvPr>
          <p:cNvSpPr/>
          <p:nvPr/>
        </p:nvSpPr>
        <p:spPr>
          <a:xfrm>
            <a:off x="10792287" y="4351923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7DF00B4F-48B1-3FE0-009A-D524E75279D5}"/>
              </a:ext>
            </a:extLst>
          </p:cNvPr>
          <p:cNvSpPr/>
          <p:nvPr/>
        </p:nvSpPr>
        <p:spPr>
          <a:xfrm>
            <a:off x="4976132" y="1831743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4CB40CCB-40F6-BAD9-D264-9833ABFD0A0F}"/>
              </a:ext>
            </a:extLst>
          </p:cNvPr>
          <p:cNvSpPr/>
          <p:nvPr/>
        </p:nvSpPr>
        <p:spPr>
          <a:xfrm>
            <a:off x="10858740" y="1444610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69DDAAF1-F2C3-C9BA-ABF8-D0423A7F6997}"/>
              </a:ext>
            </a:extLst>
          </p:cNvPr>
          <p:cNvSpPr/>
          <p:nvPr/>
        </p:nvSpPr>
        <p:spPr>
          <a:xfrm>
            <a:off x="10874332" y="1711048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2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486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0</TotalTime>
  <Words>65</Words>
  <Application>Microsoft Office PowerPoint</Application>
  <PresentationFormat>宽屏</PresentationFormat>
  <Paragraphs>3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家祺 张</dc:creator>
  <cp:lastModifiedBy>家祺 张</cp:lastModifiedBy>
  <cp:revision>12</cp:revision>
  <dcterms:created xsi:type="dcterms:W3CDTF">2024-03-21T16:48:02Z</dcterms:created>
  <dcterms:modified xsi:type="dcterms:W3CDTF">2024-04-27T07:21:04Z</dcterms:modified>
</cp:coreProperties>
</file>